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19"/>
  </p:notesMasterIdLst>
  <p:sldIdLst>
    <p:sldId id="275" r:id="rId2"/>
    <p:sldId id="276" r:id="rId3"/>
    <p:sldId id="277" r:id="rId4"/>
    <p:sldId id="260" r:id="rId5"/>
    <p:sldId id="265" r:id="rId6"/>
    <p:sldId id="266" r:id="rId7"/>
    <p:sldId id="267" r:id="rId8"/>
    <p:sldId id="268" r:id="rId9"/>
    <p:sldId id="269" r:id="rId10"/>
    <p:sldId id="270" r:id="rId11"/>
    <p:sldId id="271" r:id="rId12"/>
    <p:sldId id="272" r:id="rId13"/>
    <p:sldId id="257" r:id="rId14"/>
    <p:sldId id="258" r:id="rId15"/>
    <p:sldId id="273" r:id="rId16"/>
    <p:sldId id="274" r:id="rId17"/>
    <p:sldId id="259" r:id="rId18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589"/>
    <p:restoredTop sz="94753"/>
  </p:normalViewPr>
  <p:slideViewPr>
    <p:cSldViewPr snapToGrid="0" snapToObjects="1">
      <p:cViewPr>
        <p:scale>
          <a:sx n="127" d="100"/>
          <a:sy n="127" d="100"/>
        </p:scale>
        <p:origin x="2136" y="1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2083717-BE00-E64A-8F54-886CE4F96097}" type="datetimeFigureOut">
              <a:rPr lang="fr-FR" smtClean="0"/>
              <a:t>07/03/202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AD2B1AC-AF99-6F45-9F74-9AD858F1B68E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23821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AD2B1AC-AF99-6F45-9F74-9AD858F1B68E}" type="slidenum">
              <a:rPr lang="fr-FR" smtClean="0"/>
              <a:t>17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760463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D6DE9-7D93-D643-95D1-F775B25D58FC}" type="datetimeFigureOut">
              <a:rPr lang="fr-FR" smtClean="0"/>
              <a:t>07/03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5C172-D583-0B4C-AFFB-0D06B50B36F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447494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D6DE9-7D93-D643-95D1-F775B25D58FC}" type="datetimeFigureOut">
              <a:rPr lang="fr-FR" smtClean="0"/>
              <a:t>07/03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5C172-D583-0B4C-AFFB-0D06B50B36F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404774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D6DE9-7D93-D643-95D1-F775B25D58FC}" type="datetimeFigureOut">
              <a:rPr lang="fr-FR" smtClean="0"/>
              <a:t>07/03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5C172-D583-0B4C-AFFB-0D06B50B36F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008867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D6DE9-7D93-D643-95D1-F775B25D58FC}" type="datetimeFigureOut">
              <a:rPr lang="fr-FR" smtClean="0"/>
              <a:t>07/03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5C172-D583-0B4C-AFFB-0D06B50B36F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77190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D6DE9-7D93-D643-95D1-F775B25D58FC}" type="datetimeFigureOut">
              <a:rPr lang="fr-FR" smtClean="0"/>
              <a:t>07/03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5C172-D583-0B4C-AFFB-0D06B50B36F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7046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D6DE9-7D93-D643-95D1-F775B25D58FC}" type="datetimeFigureOut">
              <a:rPr lang="fr-FR" smtClean="0"/>
              <a:t>07/03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5C172-D583-0B4C-AFFB-0D06B50B36F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04618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D6DE9-7D93-D643-95D1-F775B25D58FC}" type="datetimeFigureOut">
              <a:rPr lang="fr-FR" smtClean="0"/>
              <a:t>07/03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5C172-D583-0B4C-AFFB-0D06B50B36F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61250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D6DE9-7D93-D643-95D1-F775B25D58FC}" type="datetimeFigureOut">
              <a:rPr lang="fr-FR" smtClean="0"/>
              <a:t>07/03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5C172-D583-0B4C-AFFB-0D06B50B36F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84080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D6DE9-7D93-D643-95D1-F775B25D58FC}" type="datetimeFigureOut">
              <a:rPr lang="fr-FR" smtClean="0"/>
              <a:t>07/03/2022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5C172-D583-0B4C-AFFB-0D06B50B36F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72913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D6DE9-7D93-D643-95D1-F775B25D58FC}" type="datetimeFigureOut">
              <a:rPr lang="fr-FR" smtClean="0"/>
              <a:t>07/03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5C172-D583-0B4C-AFFB-0D06B50B36F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839099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5D6DE9-7D93-D643-95D1-F775B25D58FC}" type="datetimeFigureOut">
              <a:rPr lang="fr-FR" smtClean="0"/>
              <a:t>07/03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15C172-D583-0B4C-AFFB-0D06B50B36F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7171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5D6DE9-7D93-D643-95D1-F775B25D58FC}" type="datetimeFigureOut">
              <a:rPr lang="fr-FR" smtClean="0"/>
              <a:t>07/03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15C172-D583-0B4C-AFFB-0D06B50B36F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455570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88EE8039-66EC-B24C-880B-321821EE71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0000" y="479156"/>
            <a:ext cx="5238000" cy="8947689"/>
          </a:xfrm>
          <a:prstGeom prst="rect">
            <a:avLst/>
          </a:prstGeom>
        </p:spPr>
      </p:pic>
      <p:sp>
        <p:nvSpPr>
          <p:cNvPr id="6" name="TextBox 6">
            <a:extLst>
              <a:ext uri="{FF2B5EF4-FFF2-40B4-BE49-F238E27FC236}">
                <a16:creationId xmlns:a16="http://schemas.microsoft.com/office/drawing/2014/main" id="{E6B08EC4-5B86-B54D-9AFF-DB1ADC45C503}"/>
              </a:ext>
            </a:extLst>
          </p:cNvPr>
          <p:cNvSpPr txBox="1"/>
          <p:nvPr/>
        </p:nvSpPr>
        <p:spPr>
          <a:xfrm>
            <a:off x="20830" y="18708"/>
            <a:ext cx="9553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able S1</a:t>
            </a:r>
          </a:p>
        </p:txBody>
      </p:sp>
    </p:spTree>
    <p:extLst>
      <p:ext uri="{BB962C8B-B14F-4D97-AF65-F5344CB8AC3E}">
        <p14:creationId xmlns:p14="http://schemas.microsoft.com/office/powerpoint/2010/main" val="179247310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4A2C3DED-3C55-4542-B221-633CE8326C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000" y="303633"/>
            <a:ext cx="6480000" cy="92987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65763102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FB3A8945-526B-5F41-B58A-A8E38EC373F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000" y="303633"/>
            <a:ext cx="6480000" cy="92987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748033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D46E4EC0-2A6C-8642-9560-AFF83FD09B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000" y="312285"/>
            <a:ext cx="6480000" cy="753315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72509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43829C93-AF4D-5E4A-ACB9-7FD5C7F60F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85200" y="376111"/>
            <a:ext cx="4287600" cy="9421248"/>
          </a:xfrm>
          <a:prstGeom prst="rect">
            <a:avLst/>
          </a:prstGeom>
        </p:spPr>
      </p:pic>
      <p:cxnSp>
        <p:nvCxnSpPr>
          <p:cNvPr id="5" name="Connecteur droit 4">
            <a:extLst>
              <a:ext uri="{FF2B5EF4-FFF2-40B4-BE49-F238E27FC236}">
                <a16:creationId xmlns:a16="http://schemas.microsoft.com/office/drawing/2014/main" id="{EDB85359-19A8-5F4F-8F7B-2C67FE84618F}"/>
              </a:ext>
            </a:extLst>
          </p:cNvPr>
          <p:cNvCxnSpPr/>
          <p:nvPr/>
        </p:nvCxnSpPr>
        <p:spPr>
          <a:xfrm>
            <a:off x="5564784" y="340414"/>
            <a:ext cx="0" cy="9504000"/>
          </a:xfrm>
          <a:prstGeom prst="line">
            <a:avLst/>
          </a:prstGeom>
          <a:ln w="12700"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Connecteur droit 5">
            <a:extLst>
              <a:ext uri="{FF2B5EF4-FFF2-40B4-BE49-F238E27FC236}">
                <a16:creationId xmlns:a16="http://schemas.microsoft.com/office/drawing/2014/main" id="{A5C73E3A-125A-C949-AD62-A26399B93715}"/>
              </a:ext>
            </a:extLst>
          </p:cNvPr>
          <p:cNvCxnSpPr/>
          <p:nvPr/>
        </p:nvCxnSpPr>
        <p:spPr>
          <a:xfrm>
            <a:off x="1284717" y="340414"/>
            <a:ext cx="0" cy="9504000"/>
          </a:xfrm>
          <a:prstGeom prst="line">
            <a:avLst/>
          </a:prstGeom>
          <a:ln w="12700"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6">
            <a:extLst>
              <a:ext uri="{FF2B5EF4-FFF2-40B4-BE49-F238E27FC236}">
                <a16:creationId xmlns:a16="http://schemas.microsoft.com/office/drawing/2014/main" id="{1899C434-A094-B84F-B2D8-4EA588438647}"/>
              </a:ext>
            </a:extLst>
          </p:cNvPr>
          <p:cNvSpPr txBox="1"/>
          <p:nvPr/>
        </p:nvSpPr>
        <p:spPr>
          <a:xfrm>
            <a:off x="20830" y="18708"/>
            <a:ext cx="9553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able S4</a:t>
            </a:r>
          </a:p>
        </p:txBody>
      </p:sp>
    </p:spTree>
    <p:extLst>
      <p:ext uri="{BB962C8B-B14F-4D97-AF65-F5344CB8AC3E}">
        <p14:creationId xmlns:p14="http://schemas.microsoft.com/office/powerpoint/2010/main" val="146138374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>
            <a:extLst>
              <a:ext uri="{FF2B5EF4-FFF2-40B4-BE49-F238E27FC236}">
                <a16:creationId xmlns:a16="http://schemas.microsoft.com/office/drawing/2014/main" id="{219FBC03-171E-7944-89F7-C3DE1063CAF2}"/>
              </a:ext>
            </a:extLst>
          </p:cNvPr>
          <p:cNvGrpSpPr/>
          <p:nvPr/>
        </p:nvGrpSpPr>
        <p:grpSpPr>
          <a:xfrm>
            <a:off x="84600" y="475487"/>
            <a:ext cx="6688800" cy="2844000"/>
            <a:chOff x="84600" y="475487"/>
            <a:chExt cx="6688800" cy="2844000"/>
          </a:xfrm>
        </p:grpSpPr>
        <p:pic>
          <p:nvPicPr>
            <p:cNvPr id="2" name="Image 1">
              <a:extLst>
                <a:ext uri="{FF2B5EF4-FFF2-40B4-BE49-F238E27FC236}">
                  <a16:creationId xmlns:a16="http://schemas.microsoft.com/office/drawing/2014/main" id="{3DE565E7-E081-DF48-AA1C-533F29C1A21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4600" y="545703"/>
              <a:ext cx="6688800" cy="2723354"/>
            </a:xfrm>
            <a:prstGeom prst="rect">
              <a:avLst/>
            </a:prstGeom>
          </p:spPr>
        </p:pic>
        <p:cxnSp>
          <p:nvCxnSpPr>
            <p:cNvPr id="5" name="Connecteur droit 4">
              <a:extLst>
                <a:ext uri="{FF2B5EF4-FFF2-40B4-BE49-F238E27FC236}">
                  <a16:creationId xmlns:a16="http://schemas.microsoft.com/office/drawing/2014/main" id="{419421EC-DA7C-7A40-A180-46385AED2731}"/>
                </a:ext>
              </a:extLst>
            </p:cNvPr>
            <p:cNvCxnSpPr/>
            <p:nvPr/>
          </p:nvCxnSpPr>
          <p:spPr>
            <a:xfrm>
              <a:off x="86336" y="475487"/>
              <a:ext cx="0" cy="284400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83FC7DC1-A72D-8148-8B9A-273D0E469170}"/>
              </a:ext>
            </a:extLst>
          </p:cNvPr>
          <p:cNvSpPr txBox="1"/>
          <p:nvPr/>
        </p:nvSpPr>
        <p:spPr>
          <a:xfrm>
            <a:off x="20830" y="18708"/>
            <a:ext cx="9553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able S5</a:t>
            </a:r>
          </a:p>
        </p:txBody>
      </p:sp>
    </p:spTree>
    <p:extLst>
      <p:ext uri="{BB962C8B-B14F-4D97-AF65-F5344CB8AC3E}">
        <p14:creationId xmlns:p14="http://schemas.microsoft.com/office/powerpoint/2010/main" val="32576250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42F69340-45E1-A34A-85C5-B06FFDF3E58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453" y="593889"/>
            <a:ext cx="6695094" cy="3099859"/>
          </a:xfrm>
          <a:prstGeom prst="rect">
            <a:avLst/>
          </a:prstGeom>
        </p:spPr>
      </p:pic>
      <p:sp>
        <p:nvSpPr>
          <p:cNvPr id="5" name="TextBox 6">
            <a:extLst>
              <a:ext uri="{FF2B5EF4-FFF2-40B4-BE49-F238E27FC236}">
                <a16:creationId xmlns:a16="http://schemas.microsoft.com/office/drawing/2014/main" id="{7B2701C6-CFCD-1C46-A08B-25806DD805BF}"/>
              </a:ext>
            </a:extLst>
          </p:cNvPr>
          <p:cNvSpPr txBox="1"/>
          <p:nvPr/>
        </p:nvSpPr>
        <p:spPr>
          <a:xfrm>
            <a:off x="20830" y="18708"/>
            <a:ext cx="9553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able S6</a:t>
            </a:r>
          </a:p>
        </p:txBody>
      </p:sp>
    </p:spTree>
    <p:extLst>
      <p:ext uri="{BB962C8B-B14F-4D97-AF65-F5344CB8AC3E}">
        <p14:creationId xmlns:p14="http://schemas.microsoft.com/office/powerpoint/2010/main" val="140056520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e 5">
            <a:extLst>
              <a:ext uri="{FF2B5EF4-FFF2-40B4-BE49-F238E27FC236}">
                <a16:creationId xmlns:a16="http://schemas.microsoft.com/office/drawing/2014/main" id="{4ADD6503-6DD1-5144-AE3E-E62F8515DCA8}"/>
              </a:ext>
            </a:extLst>
          </p:cNvPr>
          <p:cNvGrpSpPr/>
          <p:nvPr/>
        </p:nvGrpSpPr>
        <p:grpSpPr>
          <a:xfrm>
            <a:off x="99000" y="506385"/>
            <a:ext cx="6660000" cy="3691954"/>
            <a:chOff x="99000" y="506385"/>
            <a:chExt cx="6660000" cy="3691954"/>
          </a:xfrm>
        </p:grpSpPr>
        <p:pic>
          <p:nvPicPr>
            <p:cNvPr id="5" name="Image 4">
              <a:extLst>
                <a:ext uri="{FF2B5EF4-FFF2-40B4-BE49-F238E27FC236}">
                  <a16:creationId xmlns:a16="http://schemas.microsoft.com/office/drawing/2014/main" id="{8560C762-A8FD-3D44-8886-EE811EC4905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9000" y="506385"/>
              <a:ext cx="6660000" cy="3691954"/>
            </a:xfrm>
            <a:prstGeom prst="rect">
              <a:avLst/>
            </a:prstGeom>
          </p:spPr>
        </p:pic>
        <p:cxnSp>
          <p:nvCxnSpPr>
            <p:cNvPr id="7" name="Connecteur droit 6">
              <a:extLst>
                <a:ext uri="{FF2B5EF4-FFF2-40B4-BE49-F238E27FC236}">
                  <a16:creationId xmlns:a16="http://schemas.microsoft.com/office/drawing/2014/main" id="{593D1FFF-FB99-4746-8CA2-7892B6E0FDDE}"/>
                </a:ext>
              </a:extLst>
            </p:cNvPr>
            <p:cNvCxnSpPr>
              <a:cxnSpLocks/>
            </p:cNvCxnSpPr>
            <p:nvPr/>
          </p:nvCxnSpPr>
          <p:spPr>
            <a:xfrm>
              <a:off x="102645" y="2120099"/>
              <a:ext cx="0" cy="12240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Connecteur droit 7">
              <a:extLst>
                <a:ext uri="{FF2B5EF4-FFF2-40B4-BE49-F238E27FC236}">
                  <a16:creationId xmlns:a16="http://schemas.microsoft.com/office/drawing/2014/main" id="{BBA2F84E-5DCA-F64D-8051-E224CAFEBB3A}"/>
                </a:ext>
              </a:extLst>
            </p:cNvPr>
            <p:cNvCxnSpPr>
              <a:cxnSpLocks/>
            </p:cNvCxnSpPr>
            <p:nvPr/>
          </p:nvCxnSpPr>
          <p:spPr>
            <a:xfrm>
              <a:off x="102645" y="941614"/>
              <a:ext cx="0" cy="252000"/>
            </a:xfrm>
            <a:prstGeom prst="line">
              <a:avLst/>
            </a:prstGeom>
            <a:ln w="1270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" name="TextBox 6">
            <a:extLst>
              <a:ext uri="{FF2B5EF4-FFF2-40B4-BE49-F238E27FC236}">
                <a16:creationId xmlns:a16="http://schemas.microsoft.com/office/drawing/2014/main" id="{650ECC9E-F486-AC43-8800-06A121A5C41F}"/>
              </a:ext>
            </a:extLst>
          </p:cNvPr>
          <p:cNvSpPr txBox="1"/>
          <p:nvPr/>
        </p:nvSpPr>
        <p:spPr>
          <a:xfrm>
            <a:off x="20830" y="18708"/>
            <a:ext cx="9553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able S7</a:t>
            </a:r>
          </a:p>
        </p:txBody>
      </p:sp>
    </p:spTree>
    <p:extLst>
      <p:ext uri="{BB962C8B-B14F-4D97-AF65-F5344CB8AC3E}">
        <p14:creationId xmlns:p14="http://schemas.microsoft.com/office/powerpoint/2010/main" val="71572261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 3">
            <a:extLst>
              <a:ext uri="{FF2B5EF4-FFF2-40B4-BE49-F238E27FC236}">
                <a16:creationId xmlns:a16="http://schemas.microsoft.com/office/drawing/2014/main" id="{E513C7F2-7728-9F44-9AB6-D1CCA6CBB6CA}"/>
              </a:ext>
            </a:extLst>
          </p:cNvPr>
          <p:cNvGrpSpPr/>
          <p:nvPr/>
        </p:nvGrpSpPr>
        <p:grpSpPr>
          <a:xfrm>
            <a:off x="144000" y="496639"/>
            <a:ext cx="6570000" cy="2736000"/>
            <a:chOff x="144000" y="496639"/>
            <a:chExt cx="6570000" cy="2736000"/>
          </a:xfrm>
        </p:grpSpPr>
        <p:pic>
          <p:nvPicPr>
            <p:cNvPr id="3" name="Image 2">
              <a:extLst>
                <a:ext uri="{FF2B5EF4-FFF2-40B4-BE49-F238E27FC236}">
                  <a16:creationId xmlns:a16="http://schemas.microsoft.com/office/drawing/2014/main" id="{0B2AE306-FE31-164F-BF38-93808B45C47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44000" y="539167"/>
              <a:ext cx="6570000" cy="2653891"/>
            </a:xfrm>
            <a:prstGeom prst="rect">
              <a:avLst/>
            </a:prstGeom>
          </p:spPr>
        </p:pic>
        <p:cxnSp>
          <p:nvCxnSpPr>
            <p:cNvPr id="6" name="Connecteur droit 5">
              <a:extLst>
                <a:ext uri="{FF2B5EF4-FFF2-40B4-BE49-F238E27FC236}">
                  <a16:creationId xmlns:a16="http://schemas.microsoft.com/office/drawing/2014/main" id="{B3FD2898-7E93-C84C-AA79-299ECC76B9DA}"/>
                </a:ext>
              </a:extLst>
            </p:cNvPr>
            <p:cNvCxnSpPr>
              <a:cxnSpLocks/>
            </p:cNvCxnSpPr>
            <p:nvPr/>
          </p:nvCxnSpPr>
          <p:spPr>
            <a:xfrm>
              <a:off x="146333" y="496639"/>
              <a:ext cx="0" cy="273600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3BC1187E-7701-5E41-9F4F-70AF2742DA83}"/>
              </a:ext>
            </a:extLst>
          </p:cNvPr>
          <p:cNvSpPr txBox="1"/>
          <p:nvPr/>
        </p:nvSpPr>
        <p:spPr>
          <a:xfrm>
            <a:off x="20830" y="18708"/>
            <a:ext cx="9553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able S8</a:t>
            </a:r>
          </a:p>
        </p:txBody>
      </p:sp>
    </p:spTree>
    <p:extLst>
      <p:ext uri="{BB962C8B-B14F-4D97-AF65-F5344CB8AC3E}">
        <p14:creationId xmlns:p14="http://schemas.microsoft.com/office/powerpoint/2010/main" val="42343755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50BAED90-AC58-2341-A64C-0C6C4C93D8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0000" y="102128"/>
            <a:ext cx="5238000" cy="97017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95409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8CF455CD-1F2B-664B-88E8-403CB1B303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0000" y="339576"/>
            <a:ext cx="5238000" cy="39587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05178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5">
            <a:extLst>
              <a:ext uri="{FF2B5EF4-FFF2-40B4-BE49-F238E27FC236}">
                <a16:creationId xmlns:a16="http://schemas.microsoft.com/office/drawing/2014/main" id="{41F187BF-00C0-FA4C-89D1-206E459D277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79823659"/>
              </p:ext>
            </p:extLst>
          </p:nvPr>
        </p:nvGraphicFramePr>
        <p:xfrm>
          <a:off x="117000" y="494587"/>
          <a:ext cx="6624000" cy="3445869"/>
        </p:xfrm>
        <a:graphic>
          <a:graphicData uri="http://schemas.openxmlformats.org/drawingml/2006/table">
            <a:tbl>
              <a:tblPr/>
              <a:tblGrid>
                <a:gridCol w="2167392">
                  <a:extLst>
                    <a:ext uri="{9D8B030D-6E8A-4147-A177-3AD203B41FA5}">
                      <a16:colId xmlns:a16="http://schemas.microsoft.com/office/drawing/2014/main" val="673189882"/>
                    </a:ext>
                  </a:extLst>
                </a:gridCol>
                <a:gridCol w="476180">
                  <a:extLst>
                    <a:ext uri="{9D8B030D-6E8A-4147-A177-3AD203B41FA5}">
                      <a16:colId xmlns:a16="http://schemas.microsoft.com/office/drawing/2014/main" val="787500848"/>
                    </a:ext>
                  </a:extLst>
                </a:gridCol>
                <a:gridCol w="590048">
                  <a:extLst>
                    <a:ext uri="{9D8B030D-6E8A-4147-A177-3AD203B41FA5}">
                      <a16:colId xmlns:a16="http://schemas.microsoft.com/office/drawing/2014/main" val="1927744085"/>
                    </a:ext>
                  </a:extLst>
                </a:gridCol>
                <a:gridCol w="672863">
                  <a:extLst>
                    <a:ext uri="{9D8B030D-6E8A-4147-A177-3AD203B41FA5}">
                      <a16:colId xmlns:a16="http://schemas.microsoft.com/office/drawing/2014/main" val="2852757958"/>
                    </a:ext>
                  </a:extLst>
                </a:gridCol>
                <a:gridCol w="652160">
                  <a:extLst>
                    <a:ext uri="{9D8B030D-6E8A-4147-A177-3AD203B41FA5}">
                      <a16:colId xmlns:a16="http://schemas.microsoft.com/office/drawing/2014/main" val="2641610683"/>
                    </a:ext>
                  </a:extLst>
                </a:gridCol>
                <a:gridCol w="403717">
                  <a:extLst>
                    <a:ext uri="{9D8B030D-6E8A-4147-A177-3AD203B41FA5}">
                      <a16:colId xmlns:a16="http://schemas.microsoft.com/office/drawing/2014/main" val="601886450"/>
                    </a:ext>
                  </a:extLst>
                </a:gridCol>
                <a:gridCol w="548641">
                  <a:extLst>
                    <a:ext uri="{9D8B030D-6E8A-4147-A177-3AD203B41FA5}">
                      <a16:colId xmlns:a16="http://schemas.microsoft.com/office/drawing/2014/main" val="3481155575"/>
                    </a:ext>
                  </a:extLst>
                </a:gridCol>
                <a:gridCol w="590049">
                  <a:extLst>
                    <a:ext uri="{9D8B030D-6E8A-4147-A177-3AD203B41FA5}">
                      <a16:colId xmlns:a16="http://schemas.microsoft.com/office/drawing/2014/main" val="2529654589"/>
                    </a:ext>
                  </a:extLst>
                </a:gridCol>
                <a:gridCol w="522950">
                  <a:extLst>
                    <a:ext uri="{9D8B030D-6E8A-4147-A177-3AD203B41FA5}">
                      <a16:colId xmlns:a16="http://schemas.microsoft.com/office/drawing/2014/main" val="3888414790"/>
                    </a:ext>
                  </a:extLst>
                </a:gridCol>
              </a:tblGrid>
              <a:tr h="248257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Metabolic pathways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Total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Hits.cmpd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Hits.protein</a:t>
                      </a:r>
                      <a:endParaRPr lang="en-GB" sz="800" b="1" i="0" u="none" strike="noStrike" dirty="0">
                        <a:solidFill>
                          <a:srgbClr val="000000"/>
                        </a:solidFill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Raw p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-log(p)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Holm adjust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FDR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Impact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88031724"/>
                  </a:ext>
                </a:extLst>
              </a:tr>
              <a:tr h="16822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Ascorbate and aldarate metabolism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7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1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.65E-13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2.577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.75E-11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8.74E-12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5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0814126"/>
                  </a:ext>
                </a:extLst>
              </a:tr>
              <a:tr h="16822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Drug metabolism - cytochrome P450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9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2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.65E-13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2.577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.75E-11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8.74E-12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60526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7203335"/>
                  </a:ext>
                </a:extLst>
              </a:tr>
              <a:tr h="16822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Valine, leucine and isoleucine degradation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88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3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.32E-12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1.878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8.47E-11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.91E-11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89655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40324412"/>
                  </a:ext>
                </a:extLst>
              </a:tr>
              <a:tr h="16822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Retinol metabolism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44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3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.12E-11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0.949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7.08E-10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.85E-10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88372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4675879"/>
                  </a:ext>
                </a:extLst>
              </a:tr>
              <a:tr h="16822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Butanoate metabolism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9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3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.21E-08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7.9169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7.51E-07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.60E-07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.0714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9188793"/>
                  </a:ext>
                </a:extLst>
              </a:tr>
              <a:tr h="16822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Propanoate metabolism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48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8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.56E-08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7.4481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.17E-06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.92E-07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93617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7600798"/>
                  </a:ext>
                </a:extLst>
              </a:tr>
              <a:tr h="16822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Drug metabolism - other enzymes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69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2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6.92E-07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6.1601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4.15E-05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6.52E-06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30882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7168883"/>
                  </a:ext>
                </a:extLst>
              </a:tr>
              <a:tr h="16822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Linoleic acid metabolism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7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8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6.42E-05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4.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927</a:t>
                      </a:r>
                      <a:endParaRPr lang="en-CH" sz="800" b="0" i="0" u="none" strike="noStrike">
                        <a:solidFill>
                          <a:srgbClr val="000000"/>
                        </a:solidFill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0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</a:t>
                      </a:r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7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853</a:t>
                      </a:r>
                      <a:endParaRPr lang="en-CH" sz="800" b="0" i="0" u="none" strike="noStrike">
                        <a:solidFill>
                          <a:srgbClr val="000000"/>
                        </a:solidFill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00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5293</a:t>
                      </a:r>
                      <a:endParaRPr lang="en-CH" sz="800" b="0" i="0" u="none" strike="noStrike">
                        <a:solidFill>
                          <a:srgbClr val="000000"/>
                        </a:solidFill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8125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7888984"/>
                  </a:ext>
                </a:extLst>
              </a:tr>
              <a:tr h="16822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Pyruvate metabolism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45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3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0015973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.7966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092643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011714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68182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50585113"/>
                  </a:ext>
                </a:extLst>
              </a:tr>
              <a:tr h="16822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Tryptophan metabolism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84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9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0036452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.4383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20778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024058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55422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7416253"/>
                  </a:ext>
                </a:extLst>
              </a:tr>
              <a:tr h="16822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Pentose and glucuronate interconversions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2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9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0048926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.3105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27399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029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56</a:t>
                      </a:r>
                      <a:endParaRPr lang="en-CH" sz="800" b="0" i="0" u="none" strike="noStrike">
                        <a:solidFill>
                          <a:srgbClr val="000000"/>
                        </a:solidFill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32258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1937480"/>
                  </a:ext>
                </a:extLst>
              </a:tr>
              <a:tr h="16822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beta-Alanine metabolism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44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</a:t>
                      </a:r>
                      <a:endParaRPr lang="en-CH" sz="800" b="0" i="0" u="none" strike="noStrike">
                        <a:solidFill>
                          <a:srgbClr val="000000"/>
                        </a:solidFill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2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00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78102</a:t>
                      </a:r>
                      <a:endParaRPr lang="en-CH" sz="800" b="0" i="0" u="none" strike="noStrike">
                        <a:solidFill>
                          <a:srgbClr val="000000"/>
                        </a:solidFill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.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07</a:t>
                      </a:r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42956</a:t>
                      </a:r>
                      <a:endParaRPr lang="en-CH" sz="800" b="0" i="0" u="none" strike="noStrike">
                        <a:solidFill>
                          <a:srgbClr val="000000"/>
                        </a:solidFill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0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42956</a:t>
                      </a:r>
                      <a:endParaRPr lang="en-CH" sz="800" b="0" i="0" u="none" strike="noStrike">
                        <a:solidFill>
                          <a:srgbClr val="000000"/>
                        </a:solidFill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6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5116</a:t>
                      </a:r>
                      <a:endParaRPr lang="en-CH" sz="800" b="0" i="0" u="none" strike="noStrike">
                        <a:solidFill>
                          <a:srgbClr val="000000"/>
                        </a:solidFill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5118226"/>
                  </a:ext>
                </a:extLst>
              </a:tr>
              <a:tr h="16822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Fatty acid degradation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02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4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0090223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.0447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4872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045806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.1386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4458207"/>
                  </a:ext>
                </a:extLst>
              </a:tr>
              <a:tr h="16822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Glyoxylate and dicarboxylate metabolism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56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2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012773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.8937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67697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056201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58182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5277261"/>
                  </a:ext>
                </a:extLst>
              </a:tr>
              <a:tr h="16822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Lysine degradation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49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2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012773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.8937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67697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056201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58333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6186331"/>
                  </a:ext>
                </a:extLst>
              </a:tr>
              <a:tr h="16822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alpha-Linolenic acid metabolism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2</a:t>
                      </a:r>
                      <a:endParaRPr lang="en-CH" sz="800" b="0" i="0" u="none" strike="noStrike">
                        <a:solidFill>
                          <a:srgbClr val="000000"/>
                        </a:solidFill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</a:t>
                      </a:r>
                      <a:endParaRPr lang="en-CH" sz="800" b="0" i="0" u="none" strike="noStrike">
                        <a:solidFill>
                          <a:srgbClr val="000000"/>
                        </a:solidFill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5</a:t>
                      </a:r>
                      <a:endParaRPr lang="en-CH" sz="800" b="0" i="0" u="none" strike="noStrike">
                        <a:solidFill>
                          <a:srgbClr val="000000"/>
                        </a:solidFill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0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1469</a:t>
                      </a:r>
                      <a:endParaRPr lang="en-CH" sz="800" b="0" i="0" u="none" strike="noStrike">
                        <a:solidFill>
                          <a:srgbClr val="000000"/>
                        </a:solidFill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.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5021</a:t>
                      </a:r>
                      <a:endParaRPr lang="en-CH" sz="800" b="0" i="0" u="none" strike="noStrike">
                        <a:solidFill>
                          <a:srgbClr val="000000"/>
                        </a:solidFill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6049</a:t>
                      </a:r>
                      <a:endParaRPr lang="en-CH" sz="800" b="0" i="0" u="none" strike="noStrike">
                        <a:solidFill>
                          <a:srgbClr val="000000"/>
                        </a:solidFill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1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981</a:t>
                      </a:r>
                      <a:endParaRPr lang="en-CH" sz="800" b="0" i="0" u="none" strike="noStrike">
                        <a:solidFill>
                          <a:srgbClr val="000000"/>
                        </a:solidFill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7619</a:t>
                      </a:r>
                      <a:endParaRPr lang="en-CH" sz="800" b="0" i="0" u="none" strike="noStrike">
                        <a:solidFill>
                          <a:srgbClr val="000000"/>
                        </a:solidFill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7765353"/>
                  </a:ext>
                </a:extLst>
              </a:tr>
              <a:tr h="16822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Phenylalanine metabolism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4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7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048246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.3165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24123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18731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86957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5319331"/>
                  </a:ext>
                </a:extLst>
              </a:tr>
              <a:tr h="16822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Glutathione metabolism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56</a:t>
                      </a:r>
                      <a:endParaRPr lang="en-CH" sz="800" b="0" i="0" u="none" strike="noStrike">
                        <a:solidFill>
                          <a:srgbClr val="000000"/>
                        </a:solidFill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</a:t>
                      </a:r>
                      <a:endParaRPr lang="en-CH" sz="800" b="0" i="0" u="none" strike="noStrike">
                        <a:solidFill>
                          <a:srgbClr val="000000"/>
                        </a:solidFill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2</a:t>
                      </a:r>
                      <a:endParaRPr lang="en-CH" sz="800" b="0" i="0" u="none" strike="noStrike">
                        <a:solidFill>
                          <a:srgbClr val="000000"/>
                        </a:solidFill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06439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</a:t>
                      </a:r>
                      <a:endParaRPr lang="en-CH" sz="800" b="0" i="0" u="none" strike="noStrike">
                        <a:solidFill>
                          <a:srgbClr val="000000"/>
                        </a:solidFill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.1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912</a:t>
                      </a:r>
                      <a:endParaRPr lang="en-CH" sz="800" b="0" i="0" u="none" strike="noStrike">
                        <a:solidFill>
                          <a:srgbClr val="000000"/>
                        </a:solidFill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3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</a:t>
                      </a:r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55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</a:t>
                      </a:r>
                      <a:endParaRPr lang="en-CH" sz="800" b="0" i="0" u="none" strike="noStrike">
                        <a:solidFill>
                          <a:srgbClr val="000000"/>
                        </a:solidFill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2361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</a:t>
                      </a:r>
                      <a:endParaRPr lang="en-CH" sz="800" b="0" i="0" u="none" strike="noStrike">
                        <a:solidFill>
                          <a:srgbClr val="000000"/>
                        </a:solidFill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</a:t>
                      </a:r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30909</a:t>
                      </a:r>
                      <a:endParaRPr lang="en-CH" sz="800" b="0" i="0" u="none" strike="noStrike">
                        <a:solidFill>
                          <a:srgbClr val="000000"/>
                        </a:solidFill>
                        <a:effectLst/>
                        <a:latin typeface="Helvetica Neue" panose="02000503000000020004" pitchFamily="2" charset="0"/>
                        <a:ea typeface="Helvetica Neue" panose="02000503000000020004" pitchFamily="2" charset="0"/>
                        <a:cs typeface="Helvetica Neue" panose="02000503000000020004" pitchFamily="2" charset="0"/>
                      </a:endParaRP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790593"/>
                  </a:ext>
                </a:extLst>
              </a:tr>
              <a:tr h="168226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Citrate cycle (TCA cycle)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42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0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07836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2.1059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37613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0.02722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CH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Helvetica Neue" panose="02000503000000020004" pitchFamily="2" charset="0"/>
                          <a:ea typeface="Helvetica Neue" panose="02000503000000020004" pitchFamily="2" charset="0"/>
                          <a:cs typeface="Helvetica Neue" panose="02000503000000020004" pitchFamily="2" charset="0"/>
                        </a:rPr>
                        <a:t>1.2195</a:t>
                      </a:r>
                    </a:p>
                  </a:txBody>
                  <a:tcPr marL="5735" marR="5735" marT="573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9157595"/>
                  </a:ext>
                </a:extLst>
              </a:tr>
            </a:tbl>
          </a:graphicData>
        </a:graphic>
      </p:graphicFrame>
      <p:sp>
        <p:nvSpPr>
          <p:cNvPr id="6" name="TextBox 6">
            <a:extLst>
              <a:ext uri="{FF2B5EF4-FFF2-40B4-BE49-F238E27FC236}">
                <a16:creationId xmlns:a16="http://schemas.microsoft.com/office/drawing/2014/main" id="{9153C69F-F0BB-DF4C-A7FD-A64312C98424}"/>
              </a:ext>
            </a:extLst>
          </p:cNvPr>
          <p:cNvSpPr txBox="1"/>
          <p:nvPr/>
        </p:nvSpPr>
        <p:spPr>
          <a:xfrm>
            <a:off x="20830" y="18708"/>
            <a:ext cx="9553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able S2</a:t>
            </a:r>
          </a:p>
        </p:txBody>
      </p:sp>
    </p:spTree>
    <p:extLst>
      <p:ext uri="{BB962C8B-B14F-4D97-AF65-F5344CB8AC3E}">
        <p14:creationId xmlns:p14="http://schemas.microsoft.com/office/powerpoint/2010/main" val="327999604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CFA59FA2-8CCC-0A47-84E1-D3584D4B50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000" y="367551"/>
            <a:ext cx="6480000" cy="9515563"/>
          </a:xfrm>
          <a:prstGeom prst="rect">
            <a:avLst/>
          </a:prstGeom>
        </p:spPr>
      </p:pic>
      <p:sp>
        <p:nvSpPr>
          <p:cNvPr id="4" name="TextBox 6">
            <a:extLst>
              <a:ext uri="{FF2B5EF4-FFF2-40B4-BE49-F238E27FC236}">
                <a16:creationId xmlns:a16="http://schemas.microsoft.com/office/drawing/2014/main" id="{5C01936F-CE6D-2B45-8884-B9D501DEE080}"/>
              </a:ext>
            </a:extLst>
          </p:cNvPr>
          <p:cNvSpPr txBox="1"/>
          <p:nvPr/>
        </p:nvSpPr>
        <p:spPr>
          <a:xfrm>
            <a:off x="20830" y="18708"/>
            <a:ext cx="9553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able S3</a:t>
            </a:r>
          </a:p>
        </p:txBody>
      </p:sp>
    </p:spTree>
    <p:extLst>
      <p:ext uri="{BB962C8B-B14F-4D97-AF65-F5344CB8AC3E}">
        <p14:creationId xmlns:p14="http://schemas.microsoft.com/office/powerpoint/2010/main" val="328861426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980EDD50-F873-2B4E-85EE-07BFBD77603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000" y="303633"/>
            <a:ext cx="6480000" cy="92987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7837293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F0535D95-22E1-E34C-873B-23D9DCAD43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000" y="303633"/>
            <a:ext cx="6480000" cy="92987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601726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4B960D97-E0F0-3E4F-B74A-9494596FB7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000" y="303633"/>
            <a:ext cx="6480000" cy="92987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8211651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09FEA381-72E7-3E47-8130-25D35E80AB4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000" y="303633"/>
            <a:ext cx="6480000" cy="92987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765474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3</TotalTime>
  <Words>274</Words>
  <Application>Microsoft Macintosh PowerPoint</Application>
  <PresentationFormat>Format A4 (210 x 297 mm)</PresentationFormat>
  <Paragraphs>189</Paragraphs>
  <Slides>17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7</vt:i4>
      </vt:variant>
    </vt:vector>
  </HeadingPairs>
  <TitlesOfParts>
    <vt:vector size="22" baseType="lpstr">
      <vt:lpstr>Arial</vt:lpstr>
      <vt:lpstr>Calibri</vt:lpstr>
      <vt:lpstr>Calibri Light</vt:lpstr>
      <vt:lpstr>Helvetica Neue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zakia belaid</dc:creator>
  <cp:lastModifiedBy>zakia belaid</cp:lastModifiedBy>
  <cp:revision>50</cp:revision>
  <dcterms:created xsi:type="dcterms:W3CDTF">2020-03-21T10:46:23Z</dcterms:created>
  <dcterms:modified xsi:type="dcterms:W3CDTF">2022-03-06T23:03:59Z</dcterms:modified>
</cp:coreProperties>
</file>